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8" r:id="rId3"/>
    <p:sldId id="259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9"/>
  </p:normalViewPr>
  <p:slideViewPr>
    <p:cSldViewPr snapToGrid="0" snapToObjects="1" showGuides="1">
      <p:cViewPr varScale="1">
        <p:scale>
          <a:sx n="97" d="100"/>
          <a:sy n="97" d="100"/>
        </p:scale>
        <p:origin x="1752" y="20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2-06-2022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2-06-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2-06-20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3295986742399694E-2"/>
          <c:y val="9.8777233985647694E-2"/>
          <c:w val="0.93109513749441897"/>
          <c:h val="0.6845963715319518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1a'!$G$4</c:f>
              <c:strCache>
                <c:ptCount val="1"/>
                <c:pt idx="0">
                  <c:v>Cyproterone (n=2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1a'!$F$5:$F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1a'!$G$5:$G$29</c:f>
              <c:numCache>
                <c:formatCode>###0</c:formatCode>
                <c:ptCount val="25"/>
                <c:pt idx="0">
                  <c:v>5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3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5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CC4-5445-9D03-A06DB14F48AC}"/>
            </c:ext>
          </c:extLst>
        </c:ser>
        <c:ser>
          <c:idx val="1"/>
          <c:order val="1"/>
          <c:tx>
            <c:strRef>
              <c:f>'Figure 1a'!$H$4</c:f>
              <c:strCache>
                <c:ptCount val="1"/>
                <c:pt idx="0">
                  <c:v>AMX_CLA (n=35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1a'!$F$5:$F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1a'!$H$5:$H$29</c:f>
              <c:numCache>
                <c:formatCode>###0</c:formatCode>
                <c:ptCount val="2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1</c:v>
                </c:pt>
                <c:pt idx="11">
                  <c:v>0</c:v>
                </c:pt>
                <c:pt idx="12">
                  <c:v>1</c:v>
                </c:pt>
                <c:pt idx="13">
                  <c:v>1</c:v>
                </c:pt>
                <c:pt idx="14">
                  <c:v>4</c:v>
                </c:pt>
                <c:pt idx="15">
                  <c:v>10</c:v>
                </c:pt>
                <c:pt idx="16">
                  <c:v>6</c:v>
                </c:pt>
                <c:pt idx="17">
                  <c:v>5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2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CC4-5445-9D03-A06DB14F48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6139536"/>
        <c:axId val="226140352"/>
      </c:barChart>
      <c:catAx>
        <c:axId val="226139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140352"/>
        <c:crosses val="autoZero"/>
        <c:auto val="1"/>
        <c:lblAlgn val="ctr"/>
        <c:lblOffset val="100"/>
        <c:noMultiLvlLbl val="0"/>
      </c:catAx>
      <c:valAx>
        <c:axId val="226140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261395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92869641294838"/>
          <c:y val="0.11152777777777778"/>
          <c:w val="0.86601618547681536"/>
          <c:h val="0.7029472878390201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1b'!$H$4</c:f>
              <c:strCache>
                <c:ptCount val="1"/>
                <c:pt idx="0">
                  <c:v>Cyproterone (N=2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igure 1b'!$G$5:$G$29</c:f>
              <c:strCach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strCache>
            </c:strRef>
          </c:cat>
          <c:val>
            <c:numRef>
              <c:f>'Figure 1b'!$H$5:$H$29</c:f>
              <c:numCache>
                <c:formatCode>General</c:formatCode>
                <c:ptCount val="25"/>
                <c:pt idx="0" formatCode="###0">
                  <c:v>5</c:v>
                </c:pt>
                <c:pt idx="2" formatCode="###0">
                  <c:v>1</c:v>
                </c:pt>
                <c:pt idx="4" formatCode="###0">
                  <c:v>3</c:v>
                </c:pt>
                <c:pt idx="5" formatCode="###0">
                  <c:v>1</c:v>
                </c:pt>
                <c:pt idx="6" formatCode="###0">
                  <c:v>1</c:v>
                </c:pt>
                <c:pt idx="7" formatCode="###0">
                  <c:v>1</c:v>
                </c:pt>
                <c:pt idx="8" formatCode="###0">
                  <c:v>2</c:v>
                </c:pt>
                <c:pt idx="9" formatCode="###0">
                  <c:v>2</c:v>
                </c:pt>
                <c:pt idx="10" formatCode="###0">
                  <c:v>2</c:v>
                </c:pt>
                <c:pt idx="11" formatCode="###0">
                  <c:v>1</c:v>
                </c:pt>
                <c:pt idx="12" formatCode="###0">
                  <c:v>1</c:v>
                </c:pt>
                <c:pt idx="13" formatCode="###0">
                  <c:v>1</c:v>
                </c:pt>
                <c:pt idx="15" formatCode="###0">
                  <c:v>1</c:v>
                </c:pt>
                <c:pt idx="17" formatCode="###0">
                  <c:v>0</c:v>
                </c:pt>
                <c:pt idx="18" formatCode="###0">
                  <c:v>0</c:v>
                </c:pt>
                <c:pt idx="19" formatCode="###0">
                  <c:v>0</c:v>
                </c:pt>
                <c:pt idx="20" formatCode="###0">
                  <c:v>0</c:v>
                </c:pt>
                <c:pt idx="21" formatCode="###0">
                  <c:v>0</c:v>
                </c:pt>
                <c:pt idx="22" formatCode="###0">
                  <c:v>0</c:v>
                </c:pt>
                <c:pt idx="24" formatCode="###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C7-7A47-AE00-7FBCE8B2A022}"/>
            </c:ext>
          </c:extLst>
        </c:ser>
        <c:ser>
          <c:idx val="1"/>
          <c:order val="1"/>
          <c:tx>
            <c:strRef>
              <c:f>'Figure 1b'!$I$4</c:f>
              <c:strCache>
                <c:ptCount val="1"/>
                <c:pt idx="0">
                  <c:v>Cefazolin (N=19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Figure 1b'!$G$5:$G$29</c:f>
              <c:strCach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strCache>
            </c:strRef>
          </c:cat>
          <c:val>
            <c:numRef>
              <c:f>'Figure 1b'!$I$5:$I$29</c:f>
              <c:numCache>
                <c:formatCode>General</c:formatCode>
                <c:ptCount val="25"/>
                <c:pt idx="0" formatCode="###0">
                  <c:v>0</c:v>
                </c:pt>
                <c:pt idx="4" formatCode="###0">
                  <c:v>0</c:v>
                </c:pt>
                <c:pt idx="5" formatCode="###0">
                  <c:v>0</c:v>
                </c:pt>
                <c:pt idx="6" formatCode="###0">
                  <c:v>0</c:v>
                </c:pt>
                <c:pt idx="7" formatCode="###0">
                  <c:v>0</c:v>
                </c:pt>
                <c:pt idx="8" formatCode="###0">
                  <c:v>0</c:v>
                </c:pt>
                <c:pt idx="9" formatCode="###0">
                  <c:v>0</c:v>
                </c:pt>
                <c:pt idx="10" formatCode="###0">
                  <c:v>0</c:v>
                </c:pt>
                <c:pt idx="11" formatCode="###0">
                  <c:v>0</c:v>
                </c:pt>
                <c:pt idx="12" formatCode="###0">
                  <c:v>1</c:v>
                </c:pt>
                <c:pt idx="13" formatCode="###0">
                  <c:v>0</c:v>
                </c:pt>
                <c:pt idx="15" formatCode="###0">
                  <c:v>9</c:v>
                </c:pt>
                <c:pt idx="17" formatCode="###0">
                  <c:v>1</c:v>
                </c:pt>
                <c:pt idx="18" formatCode="###0">
                  <c:v>3</c:v>
                </c:pt>
                <c:pt idx="19" formatCode="###0">
                  <c:v>4</c:v>
                </c:pt>
                <c:pt idx="24" formatCode="###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C7-7A47-AE00-7FBCE8B2A0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2374168"/>
        <c:axId val="622374496"/>
      </c:barChart>
      <c:catAx>
        <c:axId val="6223741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2374496"/>
        <c:crosses val="autoZero"/>
        <c:auto val="1"/>
        <c:lblAlgn val="ctr"/>
        <c:lblOffset val="100"/>
        <c:noMultiLvlLbl val="0"/>
      </c:catAx>
      <c:valAx>
        <c:axId val="6223744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23741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2399202359365673E-2"/>
          <c:y val="3.0546977684791178E-2"/>
          <c:w val="0.94176361790564922"/>
          <c:h val="0.7407870192126744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1c'!$H$4</c:f>
              <c:strCache>
                <c:ptCount val="1"/>
                <c:pt idx="0">
                  <c:v>Cyproterone (N=22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1c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1c'!$H$5:$H$29</c:f>
              <c:numCache>
                <c:formatCode>General</c:formatCode>
                <c:ptCount val="25"/>
                <c:pt idx="0" formatCode="###0">
                  <c:v>5</c:v>
                </c:pt>
                <c:pt idx="4" formatCode="###0">
                  <c:v>3</c:v>
                </c:pt>
                <c:pt idx="5" formatCode="###0">
                  <c:v>2</c:v>
                </c:pt>
                <c:pt idx="6" formatCode="###0">
                  <c:v>1</c:v>
                </c:pt>
                <c:pt idx="7" formatCode="###0">
                  <c:v>1</c:v>
                </c:pt>
                <c:pt idx="8" formatCode="###0">
                  <c:v>2</c:v>
                </c:pt>
                <c:pt idx="9" formatCode="###0">
                  <c:v>2</c:v>
                </c:pt>
                <c:pt idx="10" formatCode="###0">
                  <c:v>2</c:v>
                </c:pt>
                <c:pt idx="11" formatCode="###0">
                  <c:v>1</c:v>
                </c:pt>
                <c:pt idx="12" formatCode="###0">
                  <c:v>1</c:v>
                </c:pt>
                <c:pt idx="13" formatCode="###0">
                  <c:v>1</c:v>
                </c:pt>
                <c:pt idx="15" formatCode="###0">
                  <c:v>1</c:v>
                </c:pt>
                <c:pt idx="16" formatCode="###0">
                  <c:v>0</c:v>
                </c:pt>
                <c:pt idx="17" formatCode="###0">
                  <c:v>0</c:v>
                </c:pt>
                <c:pt idx="20" formatCode="###0">
                  <c:v>0</c:v>
                </c:pt>
                <c:pt idx="23" formatCode="###0">
                  <c:v>0</c:v>
                </c:pt>
                <c:pt idx="24" formatCode="###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CB-C44F-97D6-CD761E8A3C77}"/>
            </c:ext>
          </c:extLst>
        </c:ser>
        <c:ser>
          <c:idx val="1"/>
          <c:order val="1"/>
          <c:tx>
            <c:strRef>
              <c:f>'Figure 1c'!$I$4</c:f>
              <c:strCache>
                <c:ptCount val="1"/>
                <c:pt idx="0">
                  <c:v>Polygonum Multiforum (N=18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1c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1c'!$I$5:$I$29</c:f>
              <c:numCache>
                <c:formatCode>General</c:formatCode>
                <c:ptCount val="25"/>
                <c:pt idx="0" formatCode="###0">
                  <c:v>0</c:v>
                </c:pt>
                <c:pt idx="4" formatCode="###0">
                  <c:v>1</c:v>
                </c:pt>
                <c:pt idx="5" formatCode="###0">
                  <c:v>0</c:v>
                </c:pt>
                <c:pt idx="6" formatCode="###0">
                  <c:v>0</c:v>
                </c:pt>
                <c:pt idx="7" formatCode="###0">
                  <c:v>0</c:v>
                </c:pt>
                <c:pt idx="8" formatCode="###0">
                  <c:v>0</c:v>
                </c:pt>
                <c:pt idx="9" formatCode="###0">
                  <c:v>0</c:v>
                </c:pt>
                <c:pt idx="10" formatCode="###0">
                  <c:v>0</c:v>
                </c:pt>
                <c:pt idx="11" formatCode="###0">
                  <c:v>1</c:v>
                </c:pt>
                <c:pt idx="12" formatCode="###0">
                  <c:v>3</c:v>
                </c:pt>
                <c:pt idx="13" formatCode="###0">
                  <c:v>0</c:v>
                </c:pt>
                <c:pt idx="15" formatCode="###0">
                  <c:v>2</c:v>
                </c:pt>
                <c:pt idx="16" formatCode="###0">
                  <c:v>4</c:v>
                </c:pt>
                <c:pt idx="17" formatCode="###0">
                  <c:v>5</c:v>
                </c:pt>
                <c:pt idx="20" formatCode="###0">
                  <c:v>1</c:v>
                </c:pt>
                <c:pt idx="23" formatCode="###0">
                  <c:v>1</c:v>
                </c:pt>
                <c:pt idx="24" formatCode="###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2CB-C44F-97D6-CD761E8A3C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6476944"/>
        <c:axId val="616481208"/>
      </c:barChart>
      <c:catAx>
        <c:axId val="6164769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481208"/>
        <c:crosses val="autoZero"/>
        <c:auto val="1"/>
        <c:lblAlgn val="ctr"/>
        <c:lblOffset val="100"/>
        <c:noMultiLvlLbl val="0"/>
      </c:catAx>
      <c:valAx>
        <c:axId val="6164812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64769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6935</cdr:x>
      <cdr:y>0.84932</cdr:y>
    </cdr:from>
    <cdr:to>
      <cdr:x>0.6935</cdr:x>
      <cdr:y>1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0ECEFE9E-0450-0F44-8B5A-07CBB2A292A1}"/>
            </a:ext>
          </a:extLst>
        </cdr:cNvPr>
        <cdr:cNvSpPr txBox="1"/>
      </cdr:nvSpPr>
      <cdr:spPr>
        <a:xfrm xmlns:a="http://schemas.openxmlformats.org/drawingml/2006/main">
          <a:off x="2410690" y="5153891"/>
          <a:ext cx="3796145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algn="ctr"/>
          <a:r>
            <a:rPr lang="en-US" sz="1800" dirty="0"/>
            <a:t>Numeric cyproterone-DILI-CAT score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583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083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310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23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537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479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049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884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19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88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65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29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96BD54C-38CA-8849-B9DF-97C5C79D28C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3701754"/>
              </p:ext>
            </p:extLst>
          </p:nvPr>
        </p:nvGraphicFramePr>
        <p:xfrm>
          <a:off x="678873" y="374073"/>
          <a:ext cx="8950036" cy="6068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CC0993B-A034-F74A-9079-A89CF7B2AC4D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9C57FA-FA08-3249-9D98-257E6D79AC0B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itle 1">
            <a:extLst>
              <a:ext uri="{FF2B5EF4-FFF2-40B4-BE49-F238E27FC236}">
                <a16:creationId xmlns:a16="http://schemas.microsoft.com/office/drawing/2014/main" id="{AF2733FA-56FD-974A-8C0E-A0AA24B8A088}"/>
              </a:ext>
            </a:extLst>
          </p:cNvPr>
          <p:cNvSpPr txBox="1">
            <a:spLocks/>
          </p:cNvSpPr>
          <p:nvPr/>
        </p:nvSpPr>
        <p:spPr>
          <a:xfrm>
            <a:off x="681037" y="212727"/>
            <a:ext cx="8543925" cy="50770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Latency weighted cyproterone-DII-CAT comparing cyproterone (n=22) to AMX/CLA (n=35)</a:t>
            </a:r>
          </a:p>
        </p:txBody>
      </p:sp>
    </p:spTree>
    <p:extLst>
      <p:ext uri="{BB962C8B-B14F-4D97-AF65-F5344CB8AC3E}">
        <p14:creationId xmlns:p14="http://schemas.microsoft.com/office/powerpoint/2010/main" val="680506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8F810E-F862-1D43-AC78-2ACA9C3A9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7" y="212727"/>
            <a:ext cx="8543925" cy="507709"/>
          </a:xfrm>
        </p:spPr>
        <p:txBody>
          <a:bodyPr>
            <a:normAutofit/>
          </a:bodyPr>
          <a:lstStyle/>
          <a:p>
            <a:pPr algn="ctr"/>
            <a:r>
              <a:rPr lang="en-US" sz="1800" dirty="0"/>
              <a:t>Latency weighted cyproterone-DII-CAT comparing cyproterone (n=22) to cefazolin (n=19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65650D7E-795D-41D2-B6A3-336132D04F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0374185"/>
              </p:ext>
            </p:extLst>
          </p:nvPr>
        </p:nvGraphicFramePr>
        <p:xfrm>
          <a:off x="1" y="720436"/>
          <a:ext cx="9628910" cy="57634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3F10570A-EBEF-AE44-972C-BAFCB294774A}"/>
              </a:ext>
            </a:extLst>
          </p:cNvPr>
          <p:cNvSpPr txBox="1"/>
          <p:nvPr/>
        </p:nvSpPr>
        <p:spPr>
          <a:xfrm>
            <a:off x="2476499" y="5752011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cyproterone-DILI-CAT score</a:t>
            </a:r>
          </a:p>
        </p:txBody>
      </p:sp>
    </p:spTree>
    <p:extLst>
      <p:ext uri="{BB962C8B-B14F-4D97-AF65-F5344CB8AC3E}">
        <p14:creationId xmlns:p14="http://schemas.microsoft.com/office/powerpoint/2010/main" val="3546282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AF64C9B4-9DBD-FE41-96F1-B29F8F5BBF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4084619"/>
              </p:ext>
            </p:extLst>
          </p:nvPr>
        </p:nvGraphicFramePr>
        <p:xfrm>
          <a:off x="540327" y="720436"/>
          <a:ext cx="8821015" cy="6137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itle 1">
            <a:extLst>
              <a:ext uri="{FF2B5EF4-FFF2-40B4-BE49-F238E27FC236}">
                <a16:creationId xmlns:a16="http://schemas.microsoft.com/office/drawing/2014/main" id="{3E8F810E-F862-1D43-AC78-2ACA9C3A9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7" y="212727"/>
            <a:ext cx="8543925" cy="507709"/>
          </a:xfrm>
        </p:spPr>
        <p:txBody>
          <a:bodyPr>
            <a:normAutofit/>
          </a:bodyPr>
          <a:lstStyle/>
          <a:p>
            <a:pPr algn="ctr"/>
            <a:r>
              <a:rPr lang="en-US" sz="1800" dirty="0"/>
              <a:t>Latency weighted cyproterone-DII-CAT comparing cyproterone (n=22) to PM (n=18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10570A-EBEF-AE44-972C-BAFCB294774A}"/>
              </a:ext>
            </a:extLst>
          </p:cNvPr>
          <p:cNvSpPr txBox="1"/>
          <p:nvPr/>
        </p:nvSpPr>
        <p:spPr>
          <a:xfrm>
            <a:off x="2476499" y="5890561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cyproterone-DILI-CAT score</a:t>
            </a:r>
          </a:p>
        </p:txBody>
      </p:sp>
    </p:spTree>
    <p:extLst>
      <p:ext uri="{BB962C8B-B14F-4D97-AF65-F5344CB8AC3E}">
        <p14:creationId xmlns:p14="http://schemas.microsoft.com/office/powerpoint/2010/main" val="38416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74</Words>
  <Application>Microsoft Macintosh PowerPoint</Application>
  <PresentationFormat>A4 Paper (210x297 mm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Latency weighted cyproterone-DII-CAT comparing cyproterone (n=22) to cefazolin (n=19)</vt:lpstr>
      <vt:lpstr>Latency weighted cyproterone-DII-CAT comparing cyproterone (n=22) to PM (n=18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s Tillmann</dc:creator>
  <cp:lastModifiedBy>Hans Tillmann</cp:lastModifiedBy>
  <cp:revision>5</cp:revision>
  <dcterms:created xsi:type="dcterms:W3CDTF">2022-04-18T11:51:12Z</dcterms:created>
  <dcterms:modified xsi:type="dcterms:W3CDTF">2022-05-19T17:52:07Z</dcterms:modified>
</cp:coreProperties>
</file>